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ru-R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 varScale="1">
        <p:scale>
          <a:sx n="86" d="100"/>
          <a:sy n="86" d="100"/>
        </p:scale>
        <p:origin x="-1542" y="-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Титульны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Подзаголовок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ru-RU" smtClean="0"/>
              <a:t>Образец подзаголовка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B37859-BF62-410C-B2B5-B004A576B478}" type="datetimeFigureOut">
              <a:rPr lang="ru-RU" smtClean="0"/>
              <a:t>06.04.2026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51ECA6-D995-42A6-B701-BF6486571CE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Заголовок и вертикальный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Вертикальный текст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B37859-BF62-410C-B2B5-B004A576B478}" type="datetimeFigureOut">
              <a:rPr lang="ru-RU" smtClean="0"/>
              <a:t>06.04.2026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51ECA6-D995-42A6-B701-BF6486571CE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Вертикальный заголовок и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Вертикальный заголовок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Вертикальный текст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B37859-BF62-410C-B2B5-B004A576B478}" type="datetimeFigureOut">
              <a:rPr lang="ru-RU" smtClean="0"/>
              <a:t>06.04.2026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51ECA6-D995-42A6-B701-BF6486571CE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Заголовок и объек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Содержимое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B37859-BF62-410C-B2B5-B004A576B478}" type="datetimeFigureOut">
              <a:rPr lang="ru-RU" smtClean="0"/>
              <a:t>06.04.2026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51ECA6-D995-42A6-B701-BF6486571CE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Заголовок раздел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B37859-BF62-410C-B2B5-B004A576B478}" type="datetimeFigureOut">
              <a:rPr lang="ru-RU" smtClean="0"/>
              <a:t>06.04.2026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51ECA6-D995-42A6-B701-BF6486571CE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Два объект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Содержимое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Содержимое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B37859-BF62-410C-B2B5-B004A576B478}" type="datetimeFigureOut">
              <a:rPr lang="ru-RU" smtClean="0"/>
              <a:t>06.04.2026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51ECA6-D995-42A6-B701-BF6486571CE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Сравнение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4" name="Содержимое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5" name="Текст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6" name="Содержимое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7" name="Дата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B37859-BF62-410C-B2B5-B004A576B478}" type="datetimeFigureOut">
              <a:rPr lang="ru-RU" smtClean="0"/>
              <a:t>06.04.2026</a:t>
            </a:fld>
            <a:endParaRPr lang="ru-RU"/>
          </a:p>
        </p:txBody>
      </p:sp>
      <p:sp>
        <p:nvSpPr>
          <p:cNvPr id="8" name="Нижний колонтитул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9" name="Номер слайда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51ECA6-D995-42A6-B701-BF6486571CE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Только заголовок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Дата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B37859-BF62-410C-B2B5-B004A576B478}" type="datetimeFigureOut">
              <a:rPr lang="ru-RU" smtClean="0"/>
              <a:t>06.04.2026</a:t>
            </a:fld>
            <a:endParaRPr lang="ru-RU"/>
          </a:p>
        </p:txBody>
      </p:sp>
      <p:sp>
        <p:nvSpPr>
          <p:cNvPr id="4" name="Нижний колонтитул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5" name="Номер слайда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51ECA6-D995-42A6-B701-BF6486571CE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Пусто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Дата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B37859-BF62-410C-B2B5-B004A576B478}" type="datetimeFigureOut">
              <a:rPr lang="ru-RU" smtClean="0"/>
              <a:t>06.04.2026</a:t>
            </a:fld>
            <a:endParaRPr lang="ru-RU"/>
          </a:p>
        </p:txBody>
      </p:sp>
      <p:sp>
        <p:nvSpPr>
          <p:cNvPr id="3" name="Нижний колонтитул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4" name="Номер слайда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51ECA6-D995-42A6-B701-BF6486571CE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Объект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Содержимое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Текст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B37859-BF62-410C-B2B5-B004A576B478}" type="datetimeFigureOut">
              <a:rPr lang="ru-RU" smtClean="0"/>
              <a:t>06.04.2026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51ECA6-D995-42A6-B701-BF6486571CE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Рисунок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Рисунок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ru-RU"/>
          </a:p>
        </p:txBody>
      </p:sp>
      <p:sp>
        <p:nvSpPr>
          <p:cNvPr id="4" name="Текст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B37859-BF62-410C-B2B5-B004A576B478}" type="datetimeFigureOut">
              <a:rPr lang="ru-RU" smtClean="0"/>
              <a:t>06.04.2026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51ECA6-D995-42A6-B701-BF6486571CE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B37859-BF62-410C-B2B5-B004A576B478}" type="datetimeFigureOut">
              <a:rPr lang="ru-RU" smtClean="0"/>
              <a:t>06.04.2026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E51ECA6-D995-42A6-B701-BF6486571CE0}" type="slidenum">
              <a:rPr lang="ru-RU" smtClean="0"/>
              <a:t>‹#›</a:t>
            </a:fld>
            <a:endParaRPr lang="ru-RU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ru-RU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Рисунок 3" descr="high_res_plot.png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285721" y="1785926"/>
            <a:ext cx="4286279" cy="3571900"/>
          </a:xfrm>
          <a:prstGeom prst="rect">
            <a:avLst/>
          </a:prstGeom>
        </p:spPr>
      </p:pic>
      <p:pic>
        <p:nvPicPr>
          <p:cNvPr id="5" name="Рисунок 4" descr="high_res_plot (1).png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4786314" y="1785926"/>
            <a:ext cx="4286280" cy="3571900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1857356" y="1071546"/>
            <a:ext cx="571823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 smtClean="0">
                <a:latin typeface="Arial" pitchFamily="34" charset="0"/>
                <a:cs typeface="Arial" pitchFamily="34" charset="0"/>
              </a:rPr>
              <a:t>   LUAD                                                       LUSC</a:t>
            </a:r>
            <a:endParaRPr lang="ru-RU" sz="2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571472" y="5929330"/>
            <a:ext cx="784702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itchFamily="34" charset="0"/>
                <a:cs typeface="Arial" pitchFamily="34" charset="0"/>
              </a:rPr>
              <a:t>Figure S2. Cancer hallmark analysis of genes associated with </a:t>
            </a:r>
            <a:r>
              <a:rPr lang="en-US" sz="1400" i="1" dirty="0">
                <a:latin typeface="Arial" pitchFamily="34" charset="0"/>
                <a:cs typeface="Arial" pitchFamily="34" charset="0"/>
              </a:rPr>
              <a:t>IRF1 </a:t>
            </a:r>
            <a:r>
              <a:rPr lang="en-US" sz="1400" dirty="0">
                <a:latin typeface="Arial" pitchFamily="34" charset="0"/>
                <a:cs typeface="Arial" pitchFamily="34" charset="0"/>
              </a:rPr>
              <a:t>using CancerHallmarks.com.</a:t>
            </a:r>
            <a:endParaRPr lang="ru-RU" sz="1400" dirty="0">
              <a:latin typeface="Arial" pitchFamily="34" charset="0"/>
              <a:cs typeface="Arial" pitchFamily="34" charset="0"/>
            </a:endParaRPr>
          </a:p>
          <a:p>
            <a:endParaRPr lang="ru-RU" sz="1400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Тема Office">
  <a:themeElements>
    <a:clrScheme name="Стандартная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Стандартная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Стандартная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17</Words>
  <Application>Microsoft Office PowerPoint</Application>
  <PresentationFormat>Экран 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Тема</vt:lpstr>
      </vt:variant>
      <vt:variant>
        <vt:i4>1</vt:i4>
      </vt:variant>
      <vt:variant>
        <vt:lpstr>Заголовки слайдов</vt:lpstr>
      </vt:variant>
      <vt:variant>
        <vt:i4>1</vt:i4>
      </vt:variant>
    </vt:vector>
  </HeadingPairs>
  <TitlesOfParts>
    <vt:vector size="2" baseType="lpstr">
      <vt:lpstr>Тема Office</vt:lpstr>
      <vt:lpstr>Слайд 1</vt:lpstr>
    </vt:vector>
  </TitlesOfParts>
  <Company>HP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Слайд 1</dc:title>
  <dc:creator>HP</dc:creator>
  <cp:lastModifiedBy>HP</cp:lastModifiedBy>
  <cp:revision>1</cp:revision>
  <dcterms:created xsi:type="dcterms:W3CDTF">2026-04-06T08:23:35Z</dcterms:created>
  <dcterms:modified xsi:type="dcterms:W3CDTF">2026-04-06T08:27:39Z</dcterms:modified>
</cp:coreProperties>
</file>